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66" d="100"/>
          <a:sy n="166" d="100"/>
        </p:scale>
        <p:origin x="-48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FE2D-0A4A-AE4E-B4B2-8C504BC11FB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69887-4BB7-D440-8235-A9096EB79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9502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FE2D-0A4A-AE4E-B4B2-8C504BC11FB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69887-4BB7-D440-8235-A9096EB79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6799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FE2D-0A4A-AE4E-B4B2-8C504BC11FB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69887-4BB7-D440-8235-A9096EB79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01975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FE2D-0A4A-AE4E-B4B2-8C504BC11FB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69887-4BB7-D440-8235-A9096EB79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74849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FE2D-0A4A-AE4E-B4B2-8C504BC11FB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69887-4BB7-D440-8235-A9096EB79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91904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FE2D-0A4A-AE4E-B4B2-8C504BC11FB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69887-4BB7-D440-8235-A9096EB79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8435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FE2D-0A4A-AE4E-B4B2-8C504BC11FB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69887-4BB7-D440-8235-A9096EB79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24002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FE2D-0A4A-AE4E-B4B2-8C504BC11FB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69887-4BB7-D440-8235-A9096EB79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05057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FE2D-0A4A-AE4E-B4B2-8C504BC11FB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69887-4BB7-D440-8235-A9096EB79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29968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FE2D-0A4A-AE4E-B4B2-8C504BC11FB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69887-4BB7-D440-8235-A9096EB79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78194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BFE2D-0A4A-AE4E-B4B2-8C504BC11FB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69887-4BB7-D440-8235-A9096EB79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9528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BFE2D-0A4A-AE4E-B4B2-8C504BC11FB4}" type="datetimeFigureOut">
              <a:rPr kumimoji="1" lang="ja-JP" altLang="en-US" smtClean="0"/>
              <a:t>11/13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69887-4BB7-D440-8235-A9096EB79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9293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"/><Relationship Id="rId3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図形グループ 5"/>
          <p:cNvGrpSpPr/>
          <p:nvPr/>
        </p:nvGrpSpPr>
        <p:grpSpPr>
          <a:xfrm>
            <a:off x="981926" y="1632415"/>
            <a:ext cx="7180147" cy="3593171"/>
            <a:chOff x="983165" y="1530195"/>
            <a:chExt cx="7180147" cy="3593171"/>
          </a:xfrm>
        </p:grpSpPr>
        <p:pic>
          <p:nvPicPr>
            <p:cNvPr id="4" name="図 3" descr="IMAGES0087.tif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83165" y="1530195"/>
              <a:ext cx="3593171" cy="3593171"/>
            </a:xfrm>
            <a:prstGeom prst="rect">
              <a:avLst/>
            </a:prstGeom>
          </p:spPr>
        </p:pic>
        <p:pic>
          <p:nvPicPr>
            <p:cNvPr id="5" name="図 4" descr="IMAGES0010.tif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70141" y="1530195"/>
              <a:ext cx="3593171" cy="3593171"/>
            </a:xfrm>
            <a:prstGeom prst="rect">
              <a:avLst/>
            </a:prstGeom>
          </p:spPr>
        </p:pic>
      </p:grpSp>
      <p:sp>
        <p:nvSpPr>
          <p:cNvPr id="7" name="テキスト ボックス 6"/>
          <p:cNvSpPr txBox="1"/>
          <p:nvPr/>
        </p:nvSpPr>
        <p:spPr>
          <a:xfrm>
            <a:off x="981926" y="1324638"/>
            <a:ext cx="35175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Arial"/>
                <a:cs typeface="Arial"/>
              </a:rPr>
              <a:t>Figure S1. Brain MRI of the patient 2-III-1. 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981926" y="5225586"/>
            <a:ext cx="718014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/>
                <a:cs typeface="Arial"/>
              </a:rPr>
              <a:t>The left panel shows the T1-weighted sagittal image, and the right panel shows the T1-weighted axial image. Marked cerebellar </a:t>
            </a:r>
            <a:r>
              <a:rPr lang="en-US" altLang="ja-JP" sz="1400" dirty="0" err="1">
                <a:latin typeface="Arial"/>
                <a:cs typeface="Arial"/>
              </a:rPr>
              <a:t>vermian</a:t>
            </a:r>
            <a:r>
              <a:rPr lang="en-US" altLang="ja-JP" sz="1400" dirty="0">
                <a:latin typeface="Arial"/>
                <a:cs typeface="Arial"/>
              </a:rPr>
              <a:t> atrophy was observed.</a:t>
            </a:r>
            <a:endParaRPr kumimoji="1" lang="ja-JP" altLang="en-US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88375469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4</Words>
  <Application>Microsoft Macintosh PowerPoint</Application>
  <PresentationFormat>画面に合わせる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orino Hiroyuki</dc:creator>
  <cp:lastModifiedBy>Morino Hiroyuki</cp:lastModifiedBy>
  <cp:revision>3</cp:revision>
  <dcterms:created xsi:type="dcterms:W3CDTF">2015-11-04T19:12:33Z</dcterms:created>
  <dcterms:modified xsi:type="dcterms:W3CDTF">2015-11-13T03:56:00Z</dcterms:modified>
</cp:coreProperties>
</file>